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  <p:sldId id="279" r:id="rId3"/>
    <p:sldId id="300" r:id="rId4"/>
    <p:sldId id="294" r:id="rId5"/>
    <p:sldId id="292" r:id="rId6"/>
    <p:sldId id="293" r:id="rId7"/>
    <p:sldId id="276" r:id="rId8"/>
    <p:sldId id="270" r:id="rId9"/>
    <p:sldId id="289" r:id="rId10"/>
    <p:sldId id="290" r:id="rId11"/>
    <p:sldId id="291" r:id="rId12"/>
    <p:sldId id="273" r:id="rId13"/>
    <p:sldId id="303" r:id="rId14"/>
    <p:sldId id="277" r:id="rId15"/>
    <p:sldId id="271" r:id="rId16"/>
    <p:sldId id="295" r:id="rId17"/>
    <p:sldId id="296" r:id="rId18"/>
    <p:sldId id="297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9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Relationship Id="rId4" Type="http://schemas.openxmlformats.org/officeDocument/2006/relationships/image" Target="../media/image24.emf"/></Relationships>
</file>

<file path=ppt/drawings/_rels/vmlDrawing10.vml.rels><?xml version="1.0" encoding="UTF-8" standalone="yes"?>
<Relationships xmlns="http://schemas.openxmlformats.org/package/2006/relationships"><Relationship Id="rId3" Type="http://schemas.openxmlformats.org/officeDocument/2006/relationships/image" Target="../media/image54.emf"/><Relationship Id="rId2" Type="http://schemas.openxmlformats.org/officeDocument/2006/relationships/image" Target="../media/image53.emf"/><Relationship Id="rId1" Type="http://schemas.openxmlformats.org/officeDocument/2006/relationships/image" Target="../media/image52.emf"/><Relationship Id="rId6" Type="http://schemas.openxmlformats.org/officeDocument/2006/relationships/image" Target="../media/image57.emf"/><Relationship Id="rId5" Type="http://schemas.openxmlformats.org/officeDocument/2006/relationships/image" Target="../media/image56.emf"/><Relationship Id="rId4" Type="http://schemas.openxmlformats.org/officeDocument/2006/relationships/image" Target="../media/image55.emf"/></Relationships>
</file>

<file path=ppt/drawings/_rels/vmlDrawing1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0.emf"/><Relationship Id="rId2" Type="http://schemas.openxmlformats.org/officeDocument/2006/relationships/image" Target="../media/image59.emf"/><Relationship Id="rId1" Type="http://schemas.openxmlformats.org/officeDocument/2006/relationships/image" Target="../media/image58.emf"/><Relationship Id="rId4" Type="http://schemas.openxmlformats.org/officeDocument/2006/relationships/image" Target="../media/image6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image" Target="../media/image25.emf"/><Relationship Id="rId4" Type="http://schemas.openxmlformats.org/officeDocument/2006/relationships/image" Target="../media/image28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image" Target="../media/image30.emf"/><Relationship Id="rId1" Type="http://schemas.openxmlformats.org/officeDocument/2006/relationships/image" Target="../media/image29.emf"/><Relationship Id="rId4" Type="http://schemas.openxmlformats.org/officeDocument/2006/relationships/image" Target="../media/image32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2" Type="http://schemas.openxmlformats.org/officeDocument/2006/relationships/image" Target="../media/image34.emf"/><Relationship Id="rId1" Type="http://schemas.openxmlformats.org/officeDocument/2006/relationships/image" Target="../media/image33.emf"/><Relationship Id="rId6" Type="http://schemas.openxmlformats.org/officeDocument/2006/relationships/image" Target="../media/image38.emf"/><Relationship Id="rId5" Type="http://schemas.openxmlformats.org/officeDocument/2006/relationships/image" Target="../media/image37.emf"/><Relationship Id="rId4" Type="http://schemas.openxmlformats.org/officeDocument/2006/relationships/image" Target="../media/image36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40.emf"/><Relationship Id="rId1" Type="http://schemas.openxmlformats.org/officeDocument/2006/relationships/image" Target="../media/image39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42.emf"/><Relationship Id="rId1" Type="http://schemas.openxmlformats.org/officeDocument/2006/relationships/image" Target="../media/image41.emf"/></Relationships>
</file>

<file path=ppt/drawings/_rels/vmlDrawing7.v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image" Target="../media/image43.emf"/></Relationships>
</file>

<file path=ppt/drawings/_rels/vmlDrawing8.vml.rels><?xml version="1.0" encoding="UTF-8" standalone="yes"?>
<Relationships xmlns="http://schemas.openxmlformats.org/package/2006/relationships"><Relationship Id="rId2" Type="http://schemas.openxmlformats.org/officeDocument/2006/relationships/image" Target="../media/image46.emf"/><Relationship Id="rId1" Type="http://schemas.openxmlformats.org/officeDocument/2006/relationships/image" Target="../media/image45.emf"/></Relationships>
</file>

<file path=ppt/drawings/_rels/vmlDrawing9.v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image" Target="../media/image48.emf"/><Relationship Id="rId1" Type="http://schemas.openxmlformats.org/officeDocument/2006/relationships/image" Target="../media/image47.emf"/><Relationship Id="rId4" Type="http://schemas.openxmlformats.org/officeDocument/2006/relationships/image" Target="../media/image50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9445AA-A5BB-49AD-A9C8-D1505FAA3F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56C33D-7FCB-41EC-AADF-B2F4739655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9D8741-2F46-4CCD-B131-4E03D0019E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C5DF41-BC75-4242-A8C7-38E2EE331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AAB1F1-FC67-49E3-AE41-59E43E35E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874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07E7C4-BCCA-4CB3-9B1A-DAD55565F9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006B50-E9C4-4C68-99AA-39CEF477CC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D391F7-F0B7-4452-84BC-FCEEB54C0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AE84A9-4B9A-4231-9792-E27B57BF3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A2D06-EEEA-4753-9CBC-546553ADC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258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769C56-7F6B-4CD2-B3F2-74112CBAE3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B7F6E0-7FC8-491F-9022-0E6C6BB3F2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28E1E4-60F4-40E5-99B8-89F919CEC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96E37A-EFFF-4CDA-85F9-7B79C2368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E87DDF-A5EE-447A-8763-5CFE358F7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08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35C5E-2BE2-4FDD-84F8-95B16B611B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A0FD97-1F00-4C16-AD79-0A086F41D2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F9F271-7DED-4C82-AF9F-D05240D46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9174C3-C311-46D7-8702-586B3B19C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461F44-C3BF-43A1-B670-0FB40BB87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762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DFD33C-561D-479B-A5EA-114D6B2D0C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24AD24-BA8F-47BD-9EDC-7E6777B90B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5B5304-CD26-4CA4-A51A-008AC93D6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BEFCBD-7FE3-434C-8CB4-B4B1C5180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CB1278-AD7B-429D-AF3C-B8FB4764C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504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F5BAFD-2245-4623-BCA6-42979E94B6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270469-B5A8-4280-95D4-26DB815018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6BCD39-BABD-42E9-9AE2-909A30FF9E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8215F5-74CF-4253-B0AE-E8650ED98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44BA03-DB44-4BEC-8FCC-72691BD1F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2422CE-47A6-4A09-9316-574224947B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570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7758D7-ED3D-43D7-8072-B68F6B6A6A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470AC4-F08B-4EF2-889D-2DB925CAE0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A9FEF5-C423-432F-A33F-50F73A5787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6B34B6-75C8-4FC9-AC4D-C2AB1E78CD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7162962-7BB7-4BB2-A273-DF0105957B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13A94FE-C7C7-46B8-BF9F-4DBFEEEFC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9BC30DD-63D0-4466-BC79-8F1F170C44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3E1B13-1E16-4E92-B6AD-E77A00246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43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E455E-32DA-4194-8678-FD141498F3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90D3D1C-A06F-4AE2-86DF-6385151C5A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84537AB-EAD6-45A9-B6EF-867A31322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8CBF208-DA99-4A29-89F8-DD4FDE229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88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36DDCD-5536-48BF-A3ED-9F7512EF2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04793B-1D1A-4740-AA06-8DD23E7785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03BD16-5E65-49C2-B157-BD4853EB4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250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E3742D-2092-4CEF-927F-17A65763F3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212CE6-9C6B-4CB0-A473-5E7F6A3EEA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C4B5EA-ED1A-418E-A088-AD7E09345F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FF44A4-3F57-4482-AE55-B8D0B608D7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14E21E-656C-41D0-8A92-A59F1B736D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85E042-2B16-4100-B686-B973CCC9D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293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D19940-68B2-4FEC-8FFA-A978EE7FC1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29151E-E5EB-4546-B9DA-7E3ACE04B8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1C5571-3479-4B46-BA55-696D82F005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64245D-3201-4936-919A-FAF169EE7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38F824-35DB-4EDE-8D49-9E643E621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C1DA6D-331C-4A41-A7C5-64203CFE4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347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2879028-9230-4984-B69F-0970A5F18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31E705-4A09-4AB3-B698-1404428EFB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878487-22E1-4A6C-9A96-A80E2DF533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0DD1E6-2F4D-4FBF-A4C6-DDD94E40D89C}" type="datetimeFigureOut">
              <a:rPr lang="en-US" smtClean="0"/>
              <a:t>3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5BD7C1-6DCC-45EE-8188-3CB168CAE6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180FA3-E10C-4A6C-919A-8ABFFECB73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29154-A65E-4C21-BCE4-CEB77997AF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70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44.emf"/><Relationship Id="rId5" Type="http://schemas.openxmlformats.org/officeDocument/2006/relationships/oleObject" Target="../embeddings/oleObject24.bin"/><Relationship Id="rId4" Type="http://schemas.openxmlformats.org/officeDocument/2006/relationships/image" Target="../media/image43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46.emf"/><Relationship Id="rId5" Type="http://schemas.openxmlformats.org/officeDocument/2006/relationships/oleObject" Target="../embeddings/oleObject26.bin"/><Relationship Id="rId4" Type="http://schemas.openxmlformats.org/officeDocument/2006/relationships/image" Target="../media/image45.em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9.bin"/><Relationship Id="rId3" Type="http://schemas.openxmlformats.org/officeDocument/2006/relationships/image" Target="../media/image51.png"/><Relationship Id="rId7" Type="http://schemas.openxmlformats.org/officeDocument/2006/relationships/image" Target="../media/image4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oleObject" Target="../embeddings/oleObject28.bin"/><Relationship Id="rId11" Type="http://schemas.openxmlformats.org/officeDocument/2006/relationships/image" Target="../media/image50.emf"/><Relationship Id="rId5" Type="http://schemas.openxmlformats.org/officeDocument/2006/relationships/image" Target="../media/image47.emf"/><Relationship Id="rId10" Type="http://schemas.openxmlformats.org/officeDocument/2006/relationships/oleObject" Target="../embeddings/oleObject30.bin"/><Relationship Id="rId4" Type="http://schemas.openxmlformats.org/officeDocument/2006/relationships/oleObject" Target="../embeddings/oleObject27.bin"/><Relationship Id="rId9" Type="http://schemas.openxmlformats.org/officeDocument/2006/relationships/image" Target="../media/image49.em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emf"/><Relationship Id="rId13" Type="http://schemas.openxmlformats.org/officeDocument/2006/relationships/oleObject" Target="../embeddings/oleObject36.bin"/><Relationship Id="rId3" Type="http://schemas.openxmlformats.org/officeDocument/2006/relationships/oleObject" Target="../embeddings/oleObject31.bin"/><Relationship Id="rId7" Type="http://schemas.openxmlformats.org/officeDocument/2006/relationships/oleObject" Target="../embeddings/oleObject33.bin"/><Relationship Id="rId12" Type="http://schemas.openxmlformats.org/officeDocument/2006/relationships/image" Target="../media/image5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53.emf"/><Relationship Id="rId11" Type="http://schemas.openxmlformats.org/officeDocument/2006/relationships/oleObject" Target="../embeddings/oleObject35.bin"/><Relationship Id="rId5" Type="http://schemas.openxmlformats.org/officeDocument/2006/relationships/oleObject" Target="../embeddings/oleObject32.bin"/><Relationship Id="rId10" Type="http://schemas.openxmlformats.org/officeDocument/2006/relationships/image" Target="../media/image55.emf"/><Relationship Id="rId4" Type="http://schemas.openxmlformats.org/officeDocument/2006/relationships/image" Target="../media/image52.emf"/><Relationship Id="rId9" Type="http://schemas.openxmlformats.org/officeDocument/2006/relationships/oleObject" Target="../embeddings/oleObject34.bin"/><Relationship Id="rId14" Type="http://schemas.openxmlformats.org/officeDocument/2006/relationships/image" Target="../media/image57.emf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emf"/><Relationship Id="rId3" Type="http://schemas.openxmlformats.org/officeDocument/2006/relationships/oleObject" Target="../embeddings/oleObject37.bin"/><Relationship Id="rId7" Type="http://schemas.openxmlformats.org/officeDocument/2006/relationships/oleObject" Target="../embeddings/oleObject3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6" Type="http://schemas.openxmlformats.org/officeDocument/2006/relationships/image" Target="../media/image59.emf"/><Relationship Id="rId5" Type="http://schemas.openxmlformats.org/officeDocument/2006/relationships/oleObject" Target="../embeddings/oleObject38.bin"/><Relationship Id="rId10" Type="http://schemas.openxmlformats.org/officeDocument/2006/relationships/image" Target="../media/image61.emf"/><Relationship Id="rId4" Type="http://schemas.openxmlformats.org/officeDocument/2006/relationships/image" Target="../media/image58.emf"/><Relationship Id="rId9" Type="http://schemas.openxmlformats.org/officeDocument/2006/relationships/oleObject" Target="../embeddings/oleObject40.bin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24.emf"/><Relationship Id="rId4" Type="http://schemas.openxmlformats.org/officeDocument/2006/relationships/image" Target="../media/image21.emf"/><Relationship Id="rId9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3" Type="http://schemas.openxmlformats.org/officeDocument/2006/relationships/oleObject" Target="../embeddings/oleObject5.bin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6.emf"/><Relationship Id="rId5" Type="http://schemas.openxmlformats.org/officeDocument/2006/relationships/oleObject" Target="../embeddings/oleObject6.bin"/><Relationship Id="rId10" Type="http://schemas.openxmlformats.org/officeDocument/2006/relationships/image" Target="../media/image28.emf"/><Relationship Id="rId4" Type="http://schemas.openxmlformats.org/officeDocument/2006/relationships/image" Target="../media/image25.emf"/><Relationship Id="rId9" Type="http://schemas.openxmlformats.org/officeDocument/2006/relationships/oleObject" Target="../embeddings/oleObject8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30.emf"/><Relationship Id="rId5" Type="http://schemas.openxmlformats.org/officeDocument/2006/relationships/oleObject" Target="../embeddings/oleObject10.bin"/><Relationship Id="rId10" Type="http://schemas.openxmlformats.org/officeDocument/2006/relationships/image" Target="../media/image32.emf"/><Relationship Id="rId4" Type="http://schemas.openxmlformats.org/officeDocument/2006/relationships/image" Target="../media/image29.emf"/><Relationship Id="rId9" Type="http://schemas.openxmlformats.org/officeDocument/2006/relationships/oleObject" Target="../embeddings/oleObject12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emf"/><Relationship Id="rId13" Type="http://schemas.openxmlformats.org/officeDocument/2006/relationships/oleObject" Target="../embeddings/oleObject18.bin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3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34.emf"/><Relationship Id="rId11" Type="http://schemas.openxmlformats.org/officeDocument/2006/relationships/oleObject" Target="../embeddings/oleObject17.bin"/><Relationship Id="rId5" Type="http://schemas.openxmlformats.org/officeDocument/2006/relationships/oleObject" Target="../embeddings/oleObject14.bin"/><Relationship Id="rId10" Type="http://schemas.openxmlformats.org/officeDocument/2006/relationships/image" Target="../media/image36.emf"/><Relationship Id="rId4" Type="http://schemas.openxmlformats.org/officeDocument/2006/relationships/image" Target="../media/image33.e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38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40.emf"/><Relationship Id="rId5" Type="http://schemas.openxmlformats.org/officeDocument/2006/relationships/oleObject" Target="../embeddings/oleObject20.bin"/><Relationship Id="rId4" Type="http://schemas.openxmlformats.org/officeDocument/2006/relationships/image" Target="../media/image39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42.emf"/><Relationship Id="rId5" Type="http://schemas.openxmlformats.org/officeDocument/2006/relationships/oleObject" Target="../embeddings/oleObject22.bin"/><Relationship Id="rId4" Type="http://schemas.openxmlformats.org/officeDocument/2006/relationships/image" Target="../media/image4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BCFA1D0B-CF49-1370-EB00-1C75190BD0CF}"/>
              </a:ext>
            </a:extLst>
          </p:cNvPr>
          <p:cNvSpPr txBox="1"/>
          <p:nvPr/>
        </p:nvSpPr>
        <p:spPr>
          <a:xfrm>
            <a:off x="2413161" y="204776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8878ED8-E752-E824-48E6-A04D1F8D549B}"/>
              </a:ext>
            </a:extLst>
          </p:cNvPr>
          <p:cNvSpPr txBox="1"/>
          <p:nvPr/>
        </p:nvSpPr>
        <p:spPr>
          <a:xfrm>
            <a:off x="6536078" y="204776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56BD63A-2CEF-8171-D418-D41536197405}"/>
              </a:ext>
            </a:extLst>
          </p:cNvPr>
          <p:cNvSpPr txBox="1"/>
          <p:nvPr/>
        </p:nvSpPr>
        <p:spPr>
          <a:xfrm>
            <a:off x="2358543" y="3757387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37A1AD2-922B-DD5E-A5F5-DDD42E14ED56}"/>
              </a:ext>
            </a:extLst>
          </p:cNvPr>
          <p:cNvSpPr txBox="1"/>
          <p:nvPr/>
        </p:nvSpPr>
        <p:spPr>
          <a:xfrm>
            <a:off x="6536077" y="3757385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6C04800-55FE-8A3B-4324-CCE5611C5D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2260" y="327384"/>
            <a:ext cx="2775931" cy="310161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7CDE0D5-3F49-6280-95C7-470E4DAF05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19806" y="603946"/>
            <a:ext cx="2840232" cy="246866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495E60A-DA5B-C4F6-E682-F4B6F394E3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82260" y="3988218"/>
            <a:ext cx="2846128" cy="265114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8C13824-00AF-294C-42BF-27240B52DED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15258" y="3785390"/>
            <a:ext cx="2959176" cy="29817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870848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1D99FCDD-E284-0AC2-DF05-BD8F081B4353}"/>
              </a:ext>
            </a:extLst>
          </p:cNvPr>
          <p:cNvSpPr txBox="1"/>
          <p:nvPr/>
        </p:nvSpPr>
        <p:spPr>
          <a:xfrm>
            <a:off x="227646" y="1545831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3D7603F-96BC-5ED8-9741-9F27A6F41FC0}"/>
              </a:ext>
            </a:extLst>
          </p:cNvPr>
          <p:cNvSpPr txBox="1"/>
          <p:nvPr/>
        </p:nvSpPr>
        <p:spPr>
          <a:xfrm>
            <a:off x="6275086" y="1545831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E318BACD-B2C6-DF78-59F7-7586412B0F0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04825" y="1892928"/>
          <a:ext cx="5591175" cy="370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0" name="Prism 10" r:id="rId3" imgW="7950388" imgH="5272828" progId="Prism10.Document">
                  <p:embed/>
                </p:oleObj>
              </mc:Choice>
              <mc:Fallback>
                <p:oleObj name="Prism 10" r:id="rId3" imgW="7950388" imgH="5272828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E318BACD-B2C6-DF78-59F7-7586412B0F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4825" y="1892928"/>
                        <a:ext cx="5591175" cy="370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7017A6FC-B459-F550-587E-058FEE80796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614108" y="1894516"/>
          <a:ext cx="5508625" cy="3706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1" name="Prism 10" r:id="rId5" imgW="7831258" imgH="5269948" progId="Prism10.Document">
                  <p:embed/>
                </p:oleObj>
              </mc:Choice>
              <mc:Fallback>
                <p:oleObj name="Prism 10" r:id="rId5" imgW="7831258" imgH="5269948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7017A6FC-B459-F550-587E-058FEE8079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614108" y="1894516"/>
                        <a:ext cx="5508625" cy="3706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4945261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124E3819-A3B3-DABF-196E-1072F1D29D5E}"/>
              </a:ext>
            </a:extLst>
          </p:cNvPr>
          <p:cNvSpPr txBox="1"/>
          <p:nvPr/>
        </p:nvSpPr>
        <p:spPr>
          <a:xfrm>
            <a:off x="169734" y="1669314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E7EC385-4EE0-D8E8-5D9C-2121C5EA2C18}"/>
              </a:ext>
            </a:extLst>
          </p:cNvPr>
          <p:cNvSpPr txBox="1"/>
          <p:nvPr/>
        </p:nvSpPr>
        <p:spPr>
          <a:xfrm>
            <a:off x="6588258" y="1669314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FDA492CB-5C21-76A3-0B19-83777BD0744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600825" y="2081666"/>
          <a:ext cx="5591175" cy="3709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4" name="Prism 10" r:id="rId3" imgW="7953268" imgH="5274628" progId="Prism10.Document">
                  <p:embed/>
                </p:oleObj>
              </mc:Choice>
              <mc:Fallback>
                <p:oleObj name="Prism 10" r:id="rId3" imgW="7953268" imgH="5274628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FDA492CB-5C21-76A3-0B19-83777BD074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600825" y="2081666"/>
                        <a:ext cx="5591175" cy="3709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D1118A6F-D733-D5A8-6672-0C7155216AB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99719" y="2029835"/>
          <a:ext cx="5486400" cy="36477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5" name="Prism 10" r:id="rId5" imgW="7930593" imgH="5271388" progId="Prism10.Document">
                  <p:embed/>
                </p:oleObj>
              </mc:Choice>
              <mc:Fallback>
                <p:oleObj name="Prism 10" r:id="rId5" imgW="7930593" imgH="5271388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D1118A6F-D733-D5A8-6672-0C7155216A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9719" y="2029835"/>
                        <a:ext cx="5486400" cy="36477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7990310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4B18242-4F0D-E589-9A9E-4DC170D75F1E}"/>
              </a:ext>
            </a:extLst>
          </p:cNvPr>
          <p:cNvSpPr txBox="1"/>
          <p:nvPr/>
        </p:nvSpPr>
        <p:spPr>
          <a:xfrm>
            <a:off x="153323" y="434389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5FFB73A7-7779-A94C-098B-2EE9AD174355}"/>
              </a:ext>
            </a:extLst>
          </p:cNvPr>
          <p:cNvGraphicFramePr>
            <a:graphicFrameLocks noGrp="1"/>
          </p:cNvGraphicFramePr>
          <p:nvPr/>
        </p:nvGraphicFramePr>
        <p:xfrm>
          <a:off x="8389993" y="936486"/>
          <a:ext cx="3747031" cy="21513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07087">
                  <a:extLst>
                    <a:ext uri="{9D8B030D-6E8A-4147-A177-3AD203B41FA5}">
                      <a16:colId xmlns:a16="http://schemas.microsoft.com/office/drawing/2014/main" val="577601251"/>
                    </a:ext>
                  </a:extLst>
                </a:gridCol>
                <a:gridCol w="2439944">
                  <a:extLst>
                    <a:ext uri="{9D8B030D-6E8A-4147-A177-3AD203B41FA5}">
                      <a16:colId xmlns:a16="http://schemas.microsoft.com/office/drawing/2014/main" val="1663744071"/>
                    </a:ext>
                  </a:extLst>
                </a:gridCol>
              </a:tblGrid>
              <a:tr h="372545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typ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 of total ORMDL protein compared to WT (in %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55137"/>
                  </a:ext>
                </a:extLst>
              </a:tr>
              <a:tr h="291239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0951184"/>
                  </a:ext>
                </a:extLst>
              </a:tr>
              <a:tr h="28058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-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3698808"/>
                  </a:ext>
                </a:extLst>
              </a:tr>
              <a:tr h="28058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1-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8712940"/>
                  </a:ext>
                </a:extLst>
              </a:tr>
              <a:tr h="28058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2-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2692859"/>
                  </a:ext>
                </a:extLst>
              </a:tr>
              <a:tr h="28058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3-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4673502"/>
                  </a:ext>
                </a:extLst>
              </a:tr>
              <a:tr h="280583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K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%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6351711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D7474E51-3093-7DD0-0280-D6C9CFF31002}"/>
              </a:ext>
            </a:extLst>
          </p:cNvPr>
          <p:cNvSpPr txBox="1"/>
          <p:nvPr/>
        </p:nvSpPr>
        <p:spPr>
          <a:xfrm>
            <a:off x="7873413" y="434388"/>
            <a:ext cx="3701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9EB0F02-7A10-B9BF-CB66-A2EC9128E484}"/>
              </a:ext>
            </a:extLst>
          </p:cNvPr>
          <p:cNvSpPr txBox="1"/>
          <p:nvPr/>
        </p:nvSpPr>
        <p:spPr>
          <a:xfrm>
            <a:off x="3924529" y="434388"/>
            <a:ext cx="3701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9A7138C-A672-BAB1-A252-90E7945C2AC0}"/>
              </a:ext>
            </a:extLst>
          </p:cNvPr>
          <p:cNvSpPr txBox="1"/>
          <p:nvPr/>
        </p:nvSpPr>
        <p:spPr>
          <a:xfrm>
            <a:off x="153323" y="3840481"/>
            <a:ext cx="3701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4ABDBE0-3528-FC5F-381B-1FAE2B81E52C}"/>
              </a:ext>
            </a:extLst>
          </p:cNvPr>
          <p:cNvSpPr txBox="1"/>
          <p:nvPr/>
        </p:nvSpPr>
        <p:spPr>
          <a:xfrm>
            <a:off x="3821806" y="3840480"/>
            <a:ext cx="3701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7B0BEFD-0457-56E0-AE3E-3C6FF5E8E1EB}"/>
              </a:ext>
            </a:extLst>
          </p:cNvPr>
          <p:cNvSpPr txBox="1"/>
          <p:nvPr/>
        </p:nvSpPr>
        <p:spPr>
          <a:xfrm>
            <a:off x="7953191" y="3840480"/>
            <a:ext cx="3701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B0647F7-8C29-02C6-76C7-861C3A8754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5890" y="524974"/>
            <a:ext cx="3385916" cy="3054096"/>
          </a:xfrm>
          <a:prstGeom prst="rect">
            <a:avLst/>
          </a:prstGeom>
        </p:spPr>
      </p:pic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28404D73-3562-383A-A058-2A4CF3E6A31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03700" y="338138"/>
          <a:ext cx="3687763" cy="3429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8" name="Prism 10" r:id="rId4" imgW="5335650" imgH="4958913" progId="Prism10.Document">
                  <p:embed/>
                </p:oleObj>
              </mc:Choice>
              <mc:Fallback>
                <p:oleObj name="Prism 10" r:id="rId4" imgW="5335650" imgH="4958913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28404D73-3562-383A-A058-2A4CF3E6A3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03700" y="338138"/>
                        <a:ext cx="3687763" cy="3429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9BF2E9ED-CCBF-FBEB-CF28-8893B6EA963D}"/>
              </a:ext>
            </a:extLst>
          </p:cNvPr>
          <p:cNvCxnSpPr>
            <a:cxnSpLocks/>
          </p:cNvCxnSpPr>
          <p:nvPr/>
        </p:nvCxnSpPr>
        <p:spPr>
          <a:xfrm flipV="1">
            <a:off x="1443390" y="2664623"/>
            <a:ext cx="274320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9CF77D3-8986-B043-7C91-C5732746978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58733" y="3840480"/>
          <a:ext cx="3287834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19" name="Prism 10" r:id="rId6" imgW="5489691" imgH="4958913" progId="Prism10.Document">
                  <p:embed/>
                </p:oleObj>
              </mc:Choice>
              <mc:Fallback>
                <p:oleObj name="Prism 10" r:id="rId6" imgW="5489691" imgH="4958913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E9CF77D3-8986-B043-7C91-C5732746978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358733" y="3840480"/>
                        <a:ext cx="3287834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F0A80A1B-C840-C0E3-8841-2C726E34CFB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04602" y="3840480"/>
          <a:ext cx="3287570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0" name="Prism 10" r:id="rId8" imgW="5489691" imgH="4960713" progId="Prism10.Document">
                  <p:embed/>
                </p:oleObj>
              </mc:Choice>
              <mc:Fallback>
                <p:oleObj name="Prism 10" r:id="rId8" imgW="5489691" imgH="4960713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F0A80A1B-C840-C0E3-8841-2C726E34CF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04602" y="3840480"/>
                        <a:ext cx="3287570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D930B3A-BAB1-1C2D-4DB8-837C40476EA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422710" y="3840480"/>
          <a:ext cx="3681596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21" name="Prism 10" r:id="rId10" imgW="5527841" imgH="4459242" progId="Prism10.Document">
                  <p:embed/>
                </p:oleObj>
              </mc:Choice>
              <mc:Fallback>
                <p:oleObj name="Prism 10" r:id="rId10" imgW="5527841" imgH="4459242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4D930B3A-BAB1-1C2D-4DB8-837C40476E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422710" y="3840480"/>
                        <a:ext cx="3681596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5553296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0294AFB-1654-4B0F-228B-2863FF084583}"/>
              </a:ext>
            </a:extLst>
          </p:cNvPr>
          <p:cNvSpPr txBox="1"/>
          <p:nvPr/>
        </p:nvSpPr>
        <p:spPr>
          <a:xfrm>
            <a:off x="759547" y="370041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F906098-AFCD-A373-8419-F7B090774CB7}"/>
              </a:ext>
            </a:extLst>
          </p:cNvPr>
          <p:cNvSpPr txBox="1"/>
          <p:nvPr/>
        </p:nvSpPr>
        <p:spPr>
          <a:xfrm>
            <a:off x="4480691" y="370041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AB4AC9C-0445-997A-09E3-8FDF1D61D68A}"/>
              </a:ext>
            </a:extLst>
          </p:cNvPr>
          <p:cNvSpPr txBox="1"/>
          <p:nvPr/>
        </p:nvSpPr>
        <p:spPr>
          <a:xfrm>
            <a:off x="7997573" y="370041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62E3485-C353-E747-313C-2FB1E5115FD8}"/>
              </a:ext>
            </a:extLst>
          </p:cNvPr>
          <p:cNvSpPr txBox="1"/>
          <p:nvPr/>
        </p:nvSpPr>
        <p:spPr>
          <a:xfrm>
            <a:off x="767963" y="3483614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91A50F-9FC9-DF0C-8646-49619154F696}"/>
              </a:ext>
            </a:extLst>
          </p:cNvPr>
          <p:cNvSpPr txBox="1"/>
          <p:nvPr/>
        </p:nvSpPr>
        <p:spPr>
          <a:xfrm>
            <a:off x="4581610" y="3483614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F75C04E-79BF-17DC-8079-5668399EE9AB}"/>
              </a:ext>
            </a:extLst>
          </p:cNvPr>
          <p:cNvSpPr txBox="1"/>
          <p:nvPr/>
        </p:nvSpPr>
        <p:spPr>
          <a:xfrm>
            <a:off x="8030016" y="3483614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F60ADB6-CBBC-04C2-3C29-656CCBD0DFC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134219" y="531770"/>
          <a:ext cx="2971800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2" name="Prism 10" r:id="rId3" imgW="5335650" imgH="5007872" progId="Prism10.Document">
                  <p:embed/>
                </p:oleObj>
              </mc:Choice>
              <mc:Fallback>
                <p:oleObj name="Prism 10" r:id="rId3" imgW="5335650" imgH="5007872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8F60ADB6-CBBC-04C2-3C29-656CCBD0DF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34219" y="531770"/>
                        <a:ext cx="2971800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995C5EDD-5FC7-F5B1-5FF7-D8791DD4E8D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753232" y="556344"/>
          <a:ext cx="2971800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3" name="Prism 10" r:id="rId5" imgW="5335650" imgH="5015432" progId="Prism10.Document">
                  <p:embed/>
                </p:oleObj>
              </mc:Choice>
              <mc:Fallback>
                <p:oleObj name="Prism 10" r:id="rId5" imgW="5335650" imgH="5015432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995C5EDD-5FC7-F5B1-5FF7-D8791DD4E8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53232" y="556344"/>
                        <a:ext cx="2971800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A355090C-C408-865C-C813-59D41842027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310819" y="556344"/>
          <a:ext cx="2971800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4" name="Prism 10" r:id="rId7" imgW="5334210" imgH="5010752" progId="Prism10.Document">
                  <p:embed/>
                </p:oleObj>
              </mc:Choice>
              <mc:Fallback>
                <p:oleObj name="Prism 10" r:id="rId7" imgW="5334210" imgH="5010752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A355090C-C408-865C-C813-59D41842027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310819" y="556344"/>
                        <a:ext cx="2971800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A9D24712-F20C-60E1-D3B4-7C2CBDB1B54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21948" y="3659781"/>
          <a:ext cx="3196342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5" name="Prism 10" r:id="rId9" imgW="5334210" imgH="4960713" progId="Prism10.Document">
                  <p:embed/>
                </p:oleObj>
              </mc:Choice>
              <mc:Fallback>
                <p:oleObj name="Prism 10" r:id="rId9" imgW="5334210" imgH="4960713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A9D24712-F20C-60E1-D3B4-7C2CBDB1B5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021948" y="3659781"/>
                        <a:ext cx="3196342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F65A0AB5-875A-2D80-8050-11BA7C8FD4F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801231" y="3734402"/>
          <a:ext cx="3196342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6" name="Prism 10" r:id="rId11" imgW="5334210" imgH="4960713" progId="Prism10.Document">
                  <p:embed/>
                </p:oleObj>
              </mc:Choice>
              <mc:Fallback>
                <p:oleObj name="Prism 10" r:id="rId11" imgW="5334210" imgH="4960713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F65A0AB5-875A-2D80-8050-11BA7C8FD4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801231" y="3734402"/>
                        <a:ext cx="3196342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43AE4544-E379-14DF-5ED5-865E0B326EF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310819" y="3714447"/>
          <a:ext cx="3194888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7" name="Prism 10" r:id="rId13" imgW="5334210" imgH="4962153" progId="Prism10.Document">
                  <p:embed/>
                </p:oleObj>
              </mc:Choice>
              <mc:Fallback>
                <p:oleObj name="Prism 10" r:id="rId13" imgW="5334210" imgH="4962153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43AE4544-E379-14DF-5ED5-865E0B326E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310819" y="3714447"/>
                        <a:ext cx="3194888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037699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D3DC872A-1AA1-1B6E-299D-07A7B2796275}"/>
              </a:ext>
            </a:extLst>
          </p:cNvPr>
          <p:cNvSpPr txBox="1"/>
          <p:nvPr/>
        </p:nvSpPr>
        <p:spPr>
          <a:xfrm>
            <a:off x="986258" y="167897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38C9D1B-A04C-41A6-CF5D-04E9761E693F}"/>
              </a:ext>
            </a:extLst>
          </p:cNvPr>
          <p:cNvSpPr txBox="1"/>
          <p:nvPr/>
        </p:nvSpPr>
        <p:spPr>
          <a:xfrm>
            <a:off x="5621254" y="167897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26C138E-5EB5-FFD9-0D82-3602842C0EF8}"/>
              </a:ext>
            </a:extLst>
          </p:cNvPr>
          <p:cNvSpPr txBox="1"/>
          <p:nvPr/>
        </p:nvSpPr>
        <p:spPr>
          <a:xfrm>
            <a:off x="997283" y="3626443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EAE33BA-CE7B-5302-601B-DC7B9784AF4D}"/>
              </a:ext>
            </a:extLst>
          </p:cNvPr>
          <p:cNvSpPr txBox="1"/>
          <p:nvPr/>
        </p:nvSpPr>
        <p:spPr>
          <a:xfrm>
            <a:off x="5621254" y="3626443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0B1EA2D2-012F-A541-843E-4E6A1C80883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57254" y="81489"/>
          <a:ext cx="3592734" cy="320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6" name="Prism 10" r:id="rId3" imgW="6435891" imgH="5734699" progId="Prism10.Document">
                  <p:embed/>
                </p:oleObj>
              </mc:Choice>
              <mc:Fallback>
                <p:oleObj name="Prism 10" r:id="rId3" imgW="6435891" imgH="5734699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0B1EA2D2-012F-A541-843E-4E6A1C8088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57254" y="81489"/>
                        <a:ext cx="3592734" cy="320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F0E6B21E-6C37-1EF5-14D6-D37850B37A3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004149" y="398729"/>
          <a:ext cx="3886581" cy="320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7" name="Prism 10" r:id="rId5" imgW="6091459" imgH="5015432" progId="Prism10.Document">
                  <p:embed/>
                </p:oleObj>
              </mc:Choice>
              <mc:Fallback>
                <p:oleObj name="Prism 10" r:id="rId5" imgW="6091459" imgH="5015432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F0E6B21E-6C37-1EF5-14D6-D37850B37A3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04149" y="398729"/>
                        <a:ext cx="3886581" cy="320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DCEB3DD8-5F53-9FE4-F4AC-E0C96B82C62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57254" y="3723595"/>
          <a:ext cx="3757339" cy="320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8" name="Prism 10" r:id="rId7" imgW="5879472" imgH="5007872" progId="Prism10.Document">
                  <p:embed/>
                </p:oleObj>
              </mc:Choice>
              <mc:Fallback>
                <p:oleObj name="Prism 10" r:id="rId7" imgW="5879472" imgH="5007872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DCEB3DD8-5F53-9FE4-F4AC-E0C96B82C6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57254" y="3723595"/>
                        <a:ext cx="3757339" cy="320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15B95DA5-B9BE-F096-E162-F34ED61D9E3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189910" y="3723595"/>
          <a:ext cx="3758184" cy="30923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9" name="Prism 10" r:id="rId9" imgW="6091459" imgH="5009312" progId="Prism10.Document">
                  <p:embed/>
                </p:oleObj>
              </mc:Choice>
              <mc:Fallback>
                <p:oleObj name="Prism 10" r:id="rId9" imgW="6091459" imgH="5009312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15B95DA5-B9BE-F096-E162-F34ED61D9E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189910" y="3723595"/>
                        <a:ext cx="3758184" cy="30923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7769798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F2082CEB-DD2F-4308-8AA8-33B37824BC12}"/>
              </a:ext>
            </a:extLst>
          </p:cNvPr>
          <p:cNvGraphicFramePr>
            <a:graphicFrameLocks noGrp="1"/>
          </p:cNvGraphicFramePr>
          <p:nvPr/>
        </p:nvGraphicFramePr>
        <p:xfrm>
          <a:off x="2691720" y="2199337"/>
          <a:ext cx="6808560" cy="313179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404280">
                  <a:extLst>
                    <a:ext uri="{9D8B030D-6E8A-4147-A177-3AD203B41FA5}">
                      <a16:colId xmlns:a16="http://schemas.microsoft.com/office/drawing/2014/main" val="2730197530"/>
                    </a:ext>
                  </a:extLst>
                </a:gridCol>
                <a:gridCol w="3404280">
                  <a:extLst>
                    <a:ext uri="{9D8B030D-6E8A-4147-A177-3AD203B41FA5}">
                      <a16:colId xmlns:a16="http://schemas.microsoft.com/office/drawing/2014/main" val="1522519671"/>
                    </a:ext>
                  </a:extLst>
                </a:gridCol>
              </a:tblGrid>
              <a:tr h="447399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uide RNA sequence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0946314"/>
                  </a:ext>
                </a:extLst>
              </a:tr>
              <a:tr h="447399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CCGTGTCATGAACAGCCG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4267153"/>
                  </a:ext>
                </a:extLst>
              </a:tr>
              <a:tr h="4473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CCGAGTGATGAATAGCC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7813808"/>
                  </a:ext>
                </a:extLst>
              </a:tr>
              <a:tr h="447399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GTCATCCATAACCTGGTG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0296670"/>
                  </a:ext>
                </a:extLst>
              </a:tr>
              <a:tr h="4473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CCTATCCCTCAGCCCTGCCA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4309694"/>
                  </a:ext>
                </a:extLst>
              </a:tr>
              <a:tr h="447399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GTGTTGGGGTTCACCTCG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7914785"/>
                  </a:ext>
                </a:extLst>
              </a:tr>
              <a:tr h="4473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CATGGAAAGTGGA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316843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4FC97A12-C0CE-40B2-A5B8-41BAC386AE80}"/>
              </a:ext>
            </a:extLst>
          </p:cNvPr>
          <p:cNvSpPr txBox="1"/>
          <p:nvPr/>
        </p:nvSpPr>
        <p:spPr>
          <a:xfrm>
            <a:off x="2381037" y="1526870"/>
            <a:ext cx="8190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List of guide RNAs used for CRISPR knockout experiment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CC7357-CC9C-2A5D-F304-A75FE5576992}"/>
              </a:ext>
            </a:extLst>
          </p:cNvPr>
          <p:cNvSpPr txBox="1"/>
          <p:nvPr/>
        </p:nvSpPr>
        <p:spPr>
          <a:xfrm>
            <a:off x="4467823" y="156190"/>
            <a:ext cx="40167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</a:p>
        </p:txBody>
      </p:sp>
    </p:spTree>
    <p:extLst>
      <p:ext uri="{BB962C8B-B14F-4D97-AF65-F5344CB8AC3E}">
        <p14:creationId xmlns:p14="http://schemas.microsoft.com/office/powerpoint/2010/main" val="14672799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F2082CEB-DD2F-4308-8AA8-33B37824BC12}"/>
              </a:ext>
            </a:extLst>
          </p:cNvPr>
          <p:cNvGraphicFramePr>
            <a:graphicFrameLocks noGrp="1"/>
          </p:cNvGraphicFramePr>
          <p:nvPr/>
        </p:nvGraphicFramePr>
        <p:xfrm>
          <a:off x="2472818" y="2165817"/>
          <a:ext cx="7246364" cy="32537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623182">
                  <a:extLst>
                    <a:ext uri="{9D8B030D-6E8A-4147-A177-3AD203B41FA5}">
                      <a16:colId xmlns:a16="http://schemas.microsoft.com/office/drawing/2014/main" val="2730197530"/>
                    </a:ext>
                  </a:extLst>
                </a:gridCol>
                <a:gridCol w="3623182">
                  <a:extLst>
                    <a:ext uri="{9D8B030D-6E8A-4147-A177-3AD203B41FA5}">
                      <a16:colId xmlns:a16="http://schemas.microsoft.com/office/drawing/2014/main" val="1522519671"/>
                    </a:ext>
                  </a:extLst>
                </a:gridCol>
              </a:tblGrid>
              <a:tr h="464816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(PRIMER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0946314"/>
                  </a:ext>
                </a:extLst>
              </a:tr>
              <a:tr h="464816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 ORMDL1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TTTCCGGCAACCACTAAAC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4267153"/>
                  </a:ext>
                </a:extLst>
              </a:tr>
              <a:tr h="4648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 ORMDL1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GCTGTCATCAGCATCTACA 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7813808"/>
                  </a:ext>
                </a:extLst>
              </a:tr>
              <a:tr h="464816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 ORMDL2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TGCGTGATGGGTAAGTTC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0296670"/>
                  </a:ext>
                </a:extLst>
              </a:tr>
              <a:tr h="4648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 ORMDL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ACAAGGGCGTGGTTTAGTG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64309694"/>
                  </a:ext>
                </a:extLst>
              </a:tr>
              <a:tr h="464816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 ORMDL3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CAGTACATCACCCTGACAC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7914785"/>
                  </a:ext>
                </a:extLst>
              </a:tr>
              <a:tr h="4648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 ORMDL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CAGCAGGAAATGAGTAGAG</a:t>
                      </a:r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316843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4FC97A12-C0CE-40B2-A5B8-41BAC386AE80}"/>
              </a:ext>
            </a:extLst>
          </p:cNvPr>
          <p:cNvSpPr txBox="1"/>
          <p:nvPr/>
        </p:nvSpPr>
        <p:spPr>
          <a:xfrm>
            <a:off x="2939623" y="1438471"/>
            <a:ext cx="8190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List of primers used to validate CRISPR knockou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ED8DAE4-BD54-1C93-3E96-23AFCA41E7C3}"/>
              </a:ext>
            </a:extLst>
          </p:cNvPr>
          <p:cNvSpPr txBox="1"/>
          <p:nvPr/>
        </p:nvSpPr>
        <p:spPr>
          <a:xfrm>
            <a:off x="4427282" y="342322"/>
            <a:ext cx="40167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</a:p>
        </p:txBody>
      </p:sp>
    </p:spTree>
    <p:extLst>
      <p:ext uri="{BB962C8B-B14F-4D97-AF65-F5344CB8AC3E}">
        <p14:creationId xmlns:p14="http://schemas.microsoft.com/office/powerpoint/2010/main" val="182430133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3DE4A61-F63C-7BED-5FDB-C1C5499AF2D9}"/>
              </a:ext>
            </a:extLst>
          </p:cNvPr>
          <p:cNvGraphicFramePr>
            <a:graphicFrameLocks noGrp="1"/>
          </p:cNvGraphicFramePr>
          <p:nvPr/>
        </p:nvGraphicFramePr>
        <p:xfrm>
          <a:off x="436375" y="2167996"/>
          <a:ext cx="11319249" cy="1524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73083">
                  <a:extLst>
                    <a:ext uri="{9D8B030D-6E8A-4147-A177-3AD203B41FA5}">
                      <a16:colId xmlns:a16="http://schemas.microsoft.com/office/drawing/2014/main" val="215098750"/>
                    </a:ext>
                  </a:extLst>
                </a:gridCol>
                <a:gridCol w="3773083">
                  <a:extLst>
                    <a:ext uri="{9D8B030D-6E8A-4147-A177-3AD203B41FA5}">
                      <a16:colId xmlns:a16="http://schemas.microsoft.com/office/drawing/2014/main" val="1279917858"/>
                    </a:ext>
                  </a:extLst>
                </a:gridCol>
                <a:gridCol w="3773083">
                  <a:extLst>
                    <a:ext uri="{9D8B030D-6E8A-4147-A177-3AD203B41FA5}">
                      <a16:colId xmlns:a16="http://schemas.microsoft.com/office/drawing/2014/main" val="2994473846"/>
                    </a:ext>
                  </a:extLst>
                </a:gridCol>
              </a:tblGrid>
              <a:tr h="163668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nse stran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sense stran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9965763"/>
                  </a:ext>
                </a:extLst>
              </a:tr>
              <a:tr h="163668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.Ri.ORMDL1.13.4 (IDT assay ID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6056780"/>
                  </a:ext>
                </a:extLst>
              </a:tr>
              <a:tr h="163668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` ACGUAUGUCUUCCUUCAUAtt 3`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` UAUGAAGGAAGACAUACGUag 3`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735256"/>
                  </a:ext>
                </a:extLst>
              </a:tr>
              <a:tr h="163668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`AGUACGACCAGAUCCAUUUtt 3`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` AAAUGGAUCUGGUCGUACUta 3`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198491"/>
                  </a:ext>
                </a:extLst>
              </a:tr>
              <a:tr h="163668">
                <a:tc>
                  <a:txBody>
                    <a:bodyPr/>
                    <a:lstStyle/>
                    <a:p>
                      <a:pPr algn="ctr"/>
                      <a:r>
                        <a:rPr lang="en-US" sz="1400" b="0" i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crambled Negative Control DsiRNA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51-01-19-08 or 51.01.19.09 (IDT assay ID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7708514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75D78596-8905-7822-6310-A31ED9AFE7C4}"/>
              </a:ext>
            </a:extLst>
          </p:cNvPr>
          <p:cNvSpPr txBox="1"/>
          <p:nvPr/>
        </p:nvSpPr>
        <p:spPr>
          <a:xfrm>
            <a:off x="4404716" y="138938"/>
            <a:ext cx="40167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5969F61-214A-0F34-ED68-590790CD292D}"/>
              </a:ext>
            </a:extLst>
          </p:cNvPr>
          <p:cNvSpPr txBox="1"/>
          <p:nvPr/>
        </p:nvSpPr>
        <p:spPr>
          <a:xfrm>
            <a:off x="2741885" y="1265729"/>
            <a:ext cx="8190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List of siRNA used to verify CRISPR knockout</a:t>
            </a:r>
          </a:p>
        </p:txBody>
      </p:sp>
    </p:spTree>
    <p:extLst>
      <p:ext uri="{BB962C8B-B14F-4D97-AF65-F5344CB8AC3E}">
        <p14:creationId xmlns:p14="http://schemas.microsoft.com/office/powerpoint/2010/main" val="286115052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A2475EC-13A2-E4A5-B86E-FE916A133AD7}"/>
              </a:ext>
            </a:extLst>
          </p:cNvPr>
          <p:cNvGraphicFramePr>
            <a:graphicFrameLocks noGrp="1"/>
          </p:cNvGraphicFramePr>
          <p:nvPr/>
        </p:nvGraphicFramePr>
        <p:xfrm>
          <a:off x="3197526" y="2011964"/>
          <a:ext cx="5418666" cy="3708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09333">
                  <a:extLst>
                    <a:ext uri="{9D8B030D-6E8A-4147-A177-3AD203B41FA5}">
                      <a16:colId xmlns:a16="http://schemas.microsoft.com/office/drawing/2014/main" val="3942208593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298377170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say ID (IDT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28139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.PT.58.381235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49942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.PT.58.205810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854405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MDL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.PT.58.2094034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99036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TLC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.PT.58.86637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55072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TLC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.PT.58.4084259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40633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TLC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.PT.58.1528653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8431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Tss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.PT.58.2836818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42493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Tss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.PT.58.2256876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85297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R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.PT.58v.4562157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8147892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0A24278-A9E4-D447-284F-039146F3CF8A}"/>
              </a:ext>
            </a:extLst>
          </p:cNvPr>
          <p:cNvSpPr txBox="1"/>
          <p:nvPr/>
        </p:nvSpPr>
        <p:spPr>
          <a:xfrm>
            <a:off x="3898479" y="205280"/>
            <a:ext cx="40167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9798C47-2BCF-DAEF-960F-F6A0A93F554E}"/>
              </a:ext>
            </a:extLst>
          </p:cNvPr>
          <p:cNvSpPr txBox="1"/>
          <p:nvPr/>
        </p:nvSpPr>
        <p:spPr>
          <a:xfrm>
            <a:off x="2653503" y="1124011"/>
            <a:ext cx="819033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List of qPCR primer probes used for real-time PCR</a:t>
            </a:r>
          </a:p>
        </p:txBody>
      </p:sp>
    </p:spTree>
    <p:extLst>
      <p:ext uri="{BB962C8B-B14F-4D97-AF65-F5344CB8AC3E}">
        <p14:creationId xmlns:p14="http://schemas.microsoft.com/office/powerpoint/2010/main" val="21365787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EC50484-62FD-6C90-4C83-9A7947DC164D}"/>
              </a:ext>
            </a:extLst>
          </p:cNvPr>
          <p:cNvSpPr txBox="1"/>
          <p:nvPr/>
        </p:nvSpPr>
        <p:spPr>
          <a:xfrm>
            <a:off x="1093947" y="307515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B32B013-1DF9-9BCA-95B0-FE128379E83B}"/>
              </a:ext>
            </a:extLst>
          </p:cNvPr>
          <p:cNvSpPr txBox="1"/>
          <p:nvPr/>
        </p:nvSpPr>
        <p:spPr>
          <a:xfrm>
            <a:off x="4652213" y="203491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4FDA2B0-D16C-3946-07CC-F107FC6ACE40}"/>
              </a:ext>
            </a:extLst>
          </p:cNvPr>
          <p:cNvSpPr txBox="1"/>
          <p:nvPr/>
        </p:nvSpPr>
        <p:spPr>
          <a:xfrm>
            <a:off x="7868543" y="175724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0E24F23-D4C2-04F2-4F05-8DDCBECBC505}"/>
              </a:ext>
            </a:extLst>
          </p:cNvPr>
          <p:cNvSpPr txBox="1"/>
          <p:nvPr/>
        </p:nvSpPr>
        <p:spPr>
          <a:xfrm>
            <a:off x="992997" y="3587920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3A3964D-7D7D-C973-9ECE-08CF1365CB94}"/>
              </a:ext>
            </a:extLst>
          </p:cNvPr>
          <p:cNvSpPr txBox="1"/>
          <p:nvPr/>
        </p:nvSpPr>
        <p:spPr>
          <a:xfrm>
            <a:off x="4565740" y="3714729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33F65DDC-1B37-179F-88C0-F2FF12824D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0236" y="516421"/>
            <a:ext cx="3012471" cy="28279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77D9BFB-C481-F7F7-910B-E1B53D99E3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2968" y="637387"/>
            <a:ext cx="3112772" cy="2791613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ACB58EE0-218D-98D6-6E52-FA703FE829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28834" y="429609"/>
            <a:ext cx="2976087" cy="300625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2D32FC00-4961-5A32-B28E-5EAB50C5FF8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13902" y="3818753"/>
            <a:ext cx="3190904" cy="2791614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82EA33F8-F7A5-8B83-3573-093BF8322CE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28834" y="3916793"/>
            <a:ext cx="3112058" cy="2595534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36CC17FF-E0A9-8291-8555-85E8226132B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78644" y="3906861"/>
            <a:ext cx="3215653" cy="2615398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34EDE238-843F-2312-9A0F-2ACEE239E4F8}"/>
              </a:ext>
            </a:extLst>
          </p:cNvPr>
          <p:cNvSpPr txBox="1"/>
          <p:nvPr/>
        </p:nvSpPr>
        <p:spPr>
          <a:xfrm>
            <a:off x="8150251" y="3685711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5637105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Picture 41" descr="A diagram of a dna sequence&#10;&#10;Description automatically generated">
            <a:extLst>
              <a:ext uri="{FF2B5EF4-FFF2-40B4-BE49-F238E27FC236}">
                <a16:creationId xmlns:a16="http://schemas.microsoft.com/office/drawing/2014/main" id="{2B9950D2-5488-94E3-4A5B-2B13A6DB76E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99" t="22661" r="24617" b="15018"/>
          <a:stretch/>
        </p:blipFill>
        <p:spPr>
          <a:xfrm>
            <a:off x="832937" y="2274835"/>
            <a:ext cx="2399592" cy="199452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3439F6B-BD3A-0B2A-4924-D0E795BFE406}"/>
              </a:ext>
            </a:extLst>
          </p:cNvPr>
          <p:cNvSpPr txBox="1"/>
          <p:nvPr/>
        </p:nvSpPr>
        <p:spPr>
          <a:xfrm>
            <a:off x="488126" y="2044002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3C851D2-C244-FF1B-4129-AAB817AEEF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3026" y="526359"/>
            <a:ext cx="3805947" cy="1143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45D1975-987B-9067-AE04-B80857F213A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93026" y="1750912"/>
            <a:ext cx="3805947" cy="11584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9CC20B5-963F-D0BD-F48B-C42B6CEAFA4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93026" y="2990931"/>
            <a:ext cx="3805947" cy="9785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08862920-5E3E-6412-B0EB-E69555D50AD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93026" y="5360676"/>
            <a:ext cx="3805947" cy="11239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B25EC5D8-DB7C-6FB2-CA21-076D4B08786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93026" y="4050997"/>
            <a:ext cx="3805947" cy="12281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25491A47-36D2-6AC4-9091-EDE5FD16F83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235445" y="903041"/>
            <a:ext cx="3610708" cy="11632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2CC1073B-92BF-1169-8F4A-6FDD3811268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235445" y="2155548"/>
            <a:ext cx="3610708" cy="1143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CE7F6EAD-0A17-56F5-8D67-D48FA26869F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235445" y="3386105"/>
            <a:ext cx="3610708" cy="13630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0CC443DD-72FD-BAFE-11DC-596DCB445B9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235445" y="4836682"/>
            <a:ext cx="3610708" cy="131017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B639586-4656-5A32-6E86-D037E772151D}"/>
              </a:ext>
            </a:extLst>
          </p:cNvPr>
          <p:cNvSpPr txBox="1"/>
          <p:nvPr/>
        </p:nvSpPr>
        <p:spPr>
          <a:xfrm>
            <a:off x="3605226" y="123384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509997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DC853D7-CAD2-3F88-7F3F-BB14268735A5}"/>
              </a:ext>
            </a:extLst>
          </p:cNvPr>
          <p:cNvSpPr txBox="1"/>
          <p:nvPr/>
        </p:nvSpPr>
        <p:spPr>
          <a:xfrm>
            <a:off x="1402346" y="1683455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8DCF418-931B-96C7-0979-C1CF4A061CFB}"/>
              </a:ext>
            </a:extLst>
          </p:cNvPr>
          <p:cNvSpPr txBox="1"/>
          <p:nvPr/>
        </p:nvSpPr>
        <p:spPr>
          <a:xfrm>
            <a:off x="3728963" y="1638844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CCB3DE6-C004-F0CF-0151-A089C771FB6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70670" y="2055899"/>
          <a:ext cx="2158294" cy="274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10" r:id="rId3" imgW="4590638" imgH="5843058" progId="Prism10.Document">
                  <p:embed/>
                </p:oleObj>
              </mc:Choice>
              <mc:Fallback>
                <p:oleObj name="Prism 10" r:id="rId3" imgW="4590638" imgH="5843058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FCCB3DE6-C004-F0CF-0151-A089C771FB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70670" y="2055899"/>
                        <a:ext cx="2158294" cy="274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910C39D2-7B17-86FC-B3A2-8E04AA1C562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958949" y="2145120"/>
          <a:ext cx="2263796" cy="274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10" r:id="rId5" imgW="4590638" imgH="5562622" progId="Prism10.Document">
                  <p:embed/>
                </p:oleObj>
              </mc:Choice>
              <mc:Fallback>
                <p:oleObj name="Prism 10" r:id="rId5" imgW="4590638" imgH="5562622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910C39D2-7B17-86FC-B3A2-8E04AA1C56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58949" y="2145120"/>
                        <a:ext cx="2263796" cy="274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01C8A1D7-B5E5-3448-D7F8-33E769CC9D5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682716" y="1980650"/>
          <a:ext cx="1994077" cy="32918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10" r:id="rId7" imgW="4054374" imgH="6688683" progId="Prism10.Document">
                  <p:embed/>
                </p:oleObj>
              </mc:Choice>
              <mc:Fallback>
                <p:oleObj name="Prism 10" r:id="rId7" imgW="4054374" imgH="6688683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01C8A1D7-B5E5-3448-D7F8-33E769CC9D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682716" y="1980650"/>
                        <a:ext cx="1994077" cy="32918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D469DF9C-8876-81DE-8461-888C55CFCC42}"/>
              </a:ext>
            </a:extLst>
          </p:cNvPr>
          <p:cNvSpPr txBox="1"/>
          <p:nvPr/>
        </p:nvSpPr>
        <p:spPr>
          <a:xfrm>
            <a:off x="6222745" y="1594234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56FB4C3-C2C7-ECFA-6255-43C329396274}"/>
              </a:ext>
            </a:extLst>
          </p:cNvPr>
          <p:cNvSpPr txBox="1"/>
          <p:nvPr/>
        </p:nvSpPr>
        <p:spPr>
          <a:xfrm>
            <a:off x="8779347" y="1594235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FA2A726B-6949-CF6E-159E-0DAE71AD343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9176675" y="1727607"/>
          <a:ext cx="1993900" cy="3578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10" r:id="rId9" imgW="4194379" imgH="7531428" progId="Prism10.Document">
                  <p:embed/>
                </p:oleObj>
              </mc:Choice>
              <mc:Fallback>
                <p:oleObj name="Prism 10" r:id="rId9" imgW="4194379" imgH="7531428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FA2A726B-6949-CF6E-159E-0DAE71AD34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176675" y="1727607"/>
                        <a:ext cx="1993900" cy="3578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543799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9E4E119-1B2A-4A8C-5A12-9924C09F4DA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60853" y="267542"/>
          <a:ext cx="4344323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10" r:id="rId3" imgW="7698812" imgH="5268508" progId="Prism10.Document">
                  <p:embed/>
                </p:oleObj>
              </mc:Choice>
              <mc:Fallback>
                <p:oleObj name="Prism 10" r:id="rId3" imgW="7698812" imgH="5268508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9E4E119-1B2A-4A8C-5A12-9924C09F4DA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60853" y="267542"/>
                        <a:ext cx="4344323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8B4874B-45AA-ECC7-E164-FE1D094536D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64301" y="80963"/>
          <a:ext cx="4389039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10" r:id="rId5" imgW="7779431" imgH="5266708" progId="Prism10.Document">
                  <p:embed/>
                </p:oleObj>
              </mc:Choice>
              <mc:Fallback>
                <p:oleObj name="Prism 10" r:id="rId5" imgW="7779431" imgH="5266708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8B4874B-45AA-ECC7-E164-FE1D094536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464301" y="80963"/>
                        <a:ext cx="4389039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FE5C05E-6EEC-C0D8-C7D0-E7A11C81EF5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397076" y="3522733"/>
          <a:ext cx="4365664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Prism 10" r:id="rId7" imgW="7743081" imgH="5272828" progId="Prism10.Document">
                  <p:embed/>
                </p:oleObj>
              </mc:Choice>
              <mc:Fallback>
                <p:oleObj name="Prism 10" r:id="rId7" imgW="7743081" imgH="5272828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6FE5C05E-6EEC-C0D8-C7D0-E7A11C81EF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97076" y="3522733"/>
                        <a:ext cx="4365664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E30B1CB-0224-3267-44BF-74F6D9D2C68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590759" y="3522733"/>
          <a:ext cx="4370373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Prism 10" r:id="rId9" imgW="7743081" imgH="5266708" progId="Prism10.Document">
                  <p:embed/>
                </p:oleObj>
              </mc:Choice>
              <mc:Fallback>
                <p:oleObj name="Prism 10" r:id="rId9" imgW="7743081" imgH="5266708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E30B1CB-0224-3267-44BF-74F6D9D2C68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590759" y="3522733"/>
                        <a:ext cx="4370373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80C40196-682A-9893-2CE9-4785D1F3F656}"/>
              </a:ext>
            </a:extLst>
          </p:cNvPr>
          <p:cNvSpPr txBox="1"/>
          <p:nvPr/>
        </p:nvSpPr>
        <p:spPr>
          <a:xfrm>
            <a:off x="1000881" y="180102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856E346-731E-BBC1-E7C5-325FD91D41D6}"/>
              </a:ext>
            </a:extLst>
          </p:cNvPr>
          <p:cNvSpPr txBox="1"/>
          <p:nvPr/>
        </p:nvSpPr>
        <p:spPr>
          <a:xfrm>
            <a:off x="6130788" y="93017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6F7A90C-1EED-A213-A0AD-7357F4B041CC}"/>
              </a:ext>
            </a:extLst>
          </p:cNvPr>
          <p:cNvSpPr txBox="1"/>
          <p:nvPr/>
        </p:nvSpPr>
        <p:spPr>
          <a:xfrm>
            <a:off x="1000882" y="3429000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4C8DE21-6A01-60B6-8E1B-B9DA87E3574F}"/>
              </a:ext>
            </a:extLst>
          </p:cNvPr>
          <p:cNvSpPr txBox="1"/>
          <p:nvPr/>
        </p:nvSpPr>
        <p:spPr>
          <a:xfrm>
            <a:off x="6197924" y="3522733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5949540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F874522-F162-B55F-C9E8-C887482F59B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882685" y="344882"/>
          <a:ext cx="4403703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10" r:id="rId3" imgW="7816142" imgH="5271388" progId="Prism10.Document">
                  <p:embed/>
                </p:oleObj>
              </mc:Choice>
              <mc:Fallback>
                <p:oleObj name="Prism 10" r:id="rId3" imgW="7816142" imgH="5271388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DF874522-F162-B55F-C9E8-C887482F59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82685" y="344882"/>
                        <a:ext cx="4403703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507595E-51F7-13CC-BCB5-58017506F9D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938445" y="161146"/>
          <a:ext cx="4423944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10" r:id="rId5" imgW="7842056" imgH="5266708" progId="Prism10.Document">
                  <p:embed/>
                </p:oleObj>
              </mc:Choice>
              <mc:Fallback>
                <p:oleObj name="Prism 10" r:id="rId5" imgW="7842056" imgH="5266708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507595E-51F7-13CC-BCB5-58017506F9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938445" y="161146"/>
                        <a:ext cx="4423944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9A5F91C-B1BF-CB8D-3971-D13B14FE7F1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840015" y="3670980"/>
          <a:ext cx="4396025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10" r:id="rId7" imgW="7801026" imgH="5271388" progId="Prism10.Document">
                  <p:embed/>
                </p:oleObj>
              </mc:Choice>
              <mc:Fallback>
                <p:oleObj name="Prism 10" r:id="rId7" imgW="7801026" imgH="5271388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E9A5F91C-B1BF-CB8D-3971-D13B14FE7F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840015" y="3670980"/>
                        <a:ext cx="4396025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8BFD7F0-3D14-96D2-25C7-3B65312A10F8}"/>
              </a:ext>
            </a:extLst>
          </p:cNvPr>
          <p:cNvSpPr txBox="1"/>
          <p:nvPr/>
        </p:nvSpPr>
        <p:spPr>
          <a:xfrm>
            <a:off x="1544706" y="95249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5F59E4A-5161-86D3-B31F-16BC62D6D242}"/>
              </a:ext>
            </a:extLst>
          </p:cNvPr>
          <p:cNvSpPr txBox="1"/>
          <p:nvPr/>
        </p:nvSpPr>
        <p:spPr>
          <a:xfrm>
            <a:off x="6542156" y="95250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FC7887-7AC3-46D3-1C45-A93AF9DD3666}"/>
              </a:ext>
            </a:extLst>
          </p:cNvPr>
          <p:cNvSpPr txBox="1"/>
          <p:nvPr/>
        </p:nvSpPr>
        <p:spPr>
          <a:xfrm>
            <a:off x="1544706" y="3409609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D7569E6-6715-9187-C946-4D419E2FC17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938445" y="3670980"/>
          <a:ext cx="4431787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Prism 10" r:id="rId9" imgW="7861851" imgH="5269948" progId="Prism10.Document">
                  <p:embed/>
                </p:oleObj>
              </mc:Choice>
              <mc:Fallback>
                <p:oleObj name="Prism 10" r:id="rId9" imgW="7861851" imgH="5269948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8D7569E6-6715-9187-C946-4D419E2FC1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938445" y="3670980"/>
                        <a:ext cx="4431787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CC4360DA-2C6A-3128-E706-2E2279737AF4}"/>
              </a:ext>
            </a:extLst>
          </p:cNvPr>
          <p:cNvSpPr txBox="1"/>
          <p:nvPr/>
        </p:nvSpPr>
        <p:spPr>
          <a:xfrm>
            <a:off x="6624655" y="3429000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771279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E9380F9-4A11-26B2-F30F-429B90FC68E3}"/>
              </a:ext>
            </a:extLst>
          </p:cNvPr>
          <p:cNvSpPr txBox="1"/>
          <p:nvPr/>
        </p:nvSpPr>
        <p:spPr>
          <a:xfrm>
            <a:off x="1979967" y="0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6AB3A17-E99C-1C91-BE6F-6FE88EAF7B98}"/>
              </a:ext>
            </a:extLst>
          </p:cNvPr>
          <p:cNvSpPr txBox="1"/>
          <p:nvPr/>
        </p:nvSpPr>
        <p:spPr>
          <a:xfrm>
            <a:off x="4601825" y="0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DE9868F-A307-4AA3-90F1-732E75AE3DDF}"/>
              </a:ext>
            </a:extLst>
          </p:cNvPr>
          <p:cNvSpPr txBox="1"/>
          <p:nvPr/>
        </p:nvSpPr>
        <p:spPr>
          <a:xfrm>
            <a:off x="7355812" y="0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12229F5-46C2-75EF-BB76-8AB9477FB205}"/>
              </a:ext>
            </a:extLst>
          </p:cNvPr>
          <p:cNvSpPr txBox="1"/>
          <p:nvPr/>
        </p:nvSpPr>
        <p:spPr>
          <a:xfrm>
            <a:off x="1915431" y="3304756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0C71950-6A3F-BAFF-0570-4D680D2E31CB}"/>
              </a:ext>
            </a:extLst>
          </p:cNvPr>
          <p:cNvSpPr txBox="1"/>
          <p:nvPr/>
        </p:nvSpPr>
        <p:spPr>
          <a:xfrm>
            <a:off x="4601826" y="3304756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4748C6F-6FE2-6E6C-BA1C-883E307E897B}"/>
              </a:ext>
            </a:extLst>
          </p:cNvPr>
          <p:cNvSpPr txBox="1"/>
          <p:nvPr/>
        </p:nvSpPr>
        <p:spPr>
          <a:xfrm>
            <a:off x="7355811" y="3304756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8F9CBD61-D97E-E435-3F71-343A642567A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298740" y="202154"/>
          <a:ext cx="2039112" cy="32475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Prism 10" r:id="rId3" imgW="4194379" imgH="6681123" progId="Prism10.Document">
                  <p:embed/>
                </p:oleObj>
              </mc:Choice>
              <mc:Fallback>
                <p:oleObj name="Prism 10" r:id="rId3" imgW="4194379" imgH="6681123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8F9CBD61-D97E-E435-3F71-343A642567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98740" y="202154"/>
                        <a:ext cx="2039112" cy="32475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967A975A-D02F-AE14-F265-DA360220A44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901385" y="155013"/>
          <a:ext cx="2011680" cy="3341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9" name="Prism 10" r:id="rId5" imgW="4194379" imgH="6969118" progId="Prism10.Document">
                  <p:embed/>
                </p:oleObj>
              </mc:Choice>
              <mc:Fallback>
                <p:oleObj name="Prism 10" r:id="rId5" imgW="4194379" imgH="6969118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967A975A-D02F-AE14-F265-DA360220A44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901385" y="155013"/>
                        <a:ext cx="2011680" cy="3341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FAA16B24-59AF-EF3C-8581-28DEE04D6ED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585798" y="202154"/>
          <a:ext cx="2039112" cy="31432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0" name="Prism 10" r:id="rId7" imgW="4334743" imgH="6688683" progId="Prism10.Document">
                  <p:embed/>
                </p:oleObj>
              </mc:Choice>
              <mc:Fallback>
                <p:oleObj name="Prism 10" r:id="rId7" imgW="4334743" imgH="6688683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FAA16B24-59AF-EF3C-8581-28DEE04D6E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585798" y="202154"/>
                        <a:ext cx="2039112" cy="31432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7EA8FE8C-5AFE-CD2A-4355-6FB9F0452D1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502854" y="3535589"/>
          <a:ext cx="2039112" cy="33351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1" name="Prism 10" r:id="rId9" imgW="3912570" imgH="6402128" progId="Prism10.Document">
                  <p:embed/>
                </p:oleObj>
              </mc:Choice>
              <mc:Fallback>
                <p:oleObj name="Prism 10" r:id="rId9" imgW="3912570" imgH="6402128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7EA8FE8C-5AFE-CD2A-4355-6FB9F0452D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502854" y="3535589"/>
                        <a:ext cx="2039112" cy="33351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DBB98054-F18A-F1AA-3B4B-858728DE55D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929333" y="3651818"/>
          <a:ext cx="2039112" cy="31647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2" name="Prism 10" r:id="rId11" imgW="4124556" imgH="6400688" progId="Prism10.Document">
                  <p:embed/>
                </p:oleObj>
              </mc:Choice>
              <mc:Fallback>
                <p:oleObj name="Prism 10" r:id="rId11" imgW="4124556" imgH="6400688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DBB98054-F18A-F1AA-3B4B-858728DE55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929333" y="3651818"/>
                        <a:ext cx="2039112" cy="31647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4E72758E-B880-B6B5-D23C-E6112556CD2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585797" y="3449664"/>
          <a:ext cx="2039112" cy="34446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3" name="Prism 10" r:id="rId13" imgW="4124556" imgH="6969118" progId="Prism10.Document">
                  <p:embed/>
                </p:oleObj>
              </mc:Choice>
              <mc:Fallback>
                <p:oleObj name="Prism 10" r:id="rId13" imgW="4124556" imgH="6969118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4E72758E-B880-B6B5-D23C-E6112556CD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585797" y="3449664"/>
                        <a:ext cx="2039112" cy="34446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383256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F29A8C8-90AF-855C-68EB-E55D6259EE3F}"/>
              </a:ext>
            </a:extLst>
          </p:cNvPr>
          <p:cNvSpPr txBox="1"/>
          <p:nvPr/>
        </p:nvSpPr>
        <p:spPr>
          <a:xfrm>
            <a:off x="266902" y="1574800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71CE17B-6915-936C-F859-1235DC921843}"/>
              </a:ext>
            </a:extLst>
          </p:cNvPr>
          <p:cNvSpPr txBox="1"/>
          <p:nvPr/>
        </p:nvSpPr>
        <p:spPr>
          <a:xfrm>
            <a:off x="6370168" y="1643331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0521709-FDDA-B7CE-955E-4E166BFFC43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656388" y="1574800"/>
          <a:ext cx="5530850" cy="370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Prism 10" r:id="rId3" imgW="7866529" imgH="5272828" progId="Prism10.Document">
                  <p:embed/>
                </p:oleObj>
              </mc:Choice>
              <mc:Fallback>
                <p:oleObj name="Prism 10" r:id="rId3" imgW="7866529" imgH="5272828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0521709-FDDA-B7CE-955E-4E166BFFC4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656388" y="1574800"/>
                        <a:ext cx="5530850" cy="370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999F7FD-7167-F02F-F64A-AC2C7FE4212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96888" y="1544638"/>
          <a:ext cx="5573712" cy="3705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3" name="Prism 10" r:id="rId5" imgW="7925914" imgH="5269948" progId="Prism10.Document">
                  <p:embed/>
                </p:oleObj>
              </mc:Choice>
              <mc:Fallback>
                <p:oleObj name="Prism 10" r:id="rId5" imgW="7925914" imgH="5269948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5999F7FD-7167-F02F-F64A-AC2C7FE4212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96888" y="1544638"/>
                        <a:ext cx="5573712" cy="3705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009979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737EA32-A28A-C517-5E3F-025825A83A8B}"/>
              </a:ext>
            </a:extLst>
          </p:cNvPr>
          <p:cNvSpPr txBox="1"/>
          <p:nvPr/>
        </p:nvSpPr>
        <p:spPr>
          <a:xfrm>
            <a:off x="659225" y="1229264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5F25C23-E97B-07C6-2C7D-4DE7D1002F57}"/>
              </a:ext>
            </a:extLst>
          </p:cNvPr>
          <p:cNvSpPr txBox="1"/>
          <p:nvPr/>
        </p:nvSpPr>
        <p:spPr>
          <a:xfrm>
            <a:off x="6394643" y="1229263"/>
            <a:ext cx="4599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C65EF35F-B395-0B26-F830-792ADAF1931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72275" y="1229263"/>
          <a:ext cx="5419725" cy="370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6" name="Prism 10" r:id="rId3" imgW="7702051" imgH="5269948" progId="Prism10.Document">
                  <p:embed/>
                </p:oleObj>
              </mc:Choice>
              <mc:Fallback>
                <p:oleObj name="Prism 10" r:id="rId3" imgW="7702051" imgH="5269948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C65EF35F-B395-0B26-F830-792ADAF193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772275" y="1229263"/>
                        <a:ext cx="5419725" cy="370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063F8925-B6EF-5536-EFA7-40CEA569102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89210" y="1460095"/>
          <a:ext cx="5575300" cy="3706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7" name="Prism 10" r:id="rId5" imgW="7924475" imgH="5266708" progId="Prism10.Document">
                  <p:embed/>
                </p:oleObj>
              </mc:Choice>
              <mc:Fallback>
                <p:oleObj name="Prism 10" r:id="rId5" imgW="7924475" imgH="5266708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063F8925-B6EF-5536-EFA7-40CEA56910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89210" y="1460095"/>
                        <a:ext cx="5575300" cy="3706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30254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9</Words>
  <Application>Microsoft Office PowerPoint</Application>
  <PresentationFormat>Widescreen</PresentationFormat>
  <Paragraphs>137</Paragraphs>
  <Slides>1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3" baseType="lpstr">
      <vt:lpstr>Arial</vt:lpstr>
      <vt:lpstr>Calibri</vt:lpstr>
      <vt:lpstr>Calibri Light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an Wattenberg</dc:creator>
  <cp:lastModifiedBy>Brian Wattenberg</cp:lastModifiedBy>
  <cp:revision>1</cp:revision>
  <dcterms:created xsi:type="dcterms:W3CDTF">2025-03-14T15:03:52Z</dcterms:created>
  <dcterms:modified xsi:type="dcterms:W3CDTF">2025-03-14T15:04:33Z</dcterms:modified>
</cp:coreProperties>
</file>